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63" r:id="rId2"/>
  </p:sldIdLst>
  <p:sldSz cx="12192000" cy="6858000"/>
  <p:notesSz cx="6802438" cy="99345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198" autoAdjust="0"/>
    <p:restoredTop sz="94921" autoAdjust="0"/>
  </p:normalViewPr>
  <p:slideViewPr>
    <p:cSldViewPr snapToGrid="0">
      <p:cViewPr varScale="1">
        <p:scale>
          <a:sx n="89" d="100"/>
          <a:sy n="89" d="100"/>
        </p:scale>
        <p:origin x="456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CC400-6E8B-488F-B0D8-EF4C01DDC8E2}" type="datetimeFigureOut">
              <a:rPr lang="en-IN" smtClean="0"/>
              <a:t>22-12-2019</a:t>
            </a:fld>
            <a:endParaRPr lang="en-IN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06E18-C386-4AF2-ACEC-D4ABCF2B18FE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38643308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CC400-6E8B-488F-B0D8-EF4C01DDC8E2}" type="datetimeFigureOut">
              <a:rPr lang="en-IN" smtClean="0"/>
              <a:t>22-12-2019</a:t>
            </a:fld>
            <a:endParaRPr lang="en-IN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06E18-C386-4AF2-ACEC-D4ABCF2B18FE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8581582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CC400-6E8B-488F-B0D8-EF4C01DDC8E2}" type="datetimeFigureOut">
              <a:rPr lang="en-IN" smtClean="0"/>
              <a:t>22-12-2019</a:t>
            </a:fld>
            <a:endParaRPr lang="en-IN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06E18-C386-4AF2-ACEC-D4ABCF2B18FE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22996976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CC400-6E8B-488F-B0D8-EF4C01DDC8E2}" type="datetimeFigureOut">
              <a:rPr lang="en-IN" smtClean="0"/>
              <a:t>22-12-2019</a:t>
            </a:fld>
            <a:endParaRPr lang="en-IN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06E18-C386-4AF2-ACEC-D4ABCF2B18FE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887762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CC400-6E8B-488F-B0D8-EF4C01DDC8E2}" type="datetimeFigureOut">
              <a:rPr lang="en-IN" smtClean="0"/>
              <a:t>22-12-2019</a:t>
            </a:fld>
            <a:endParaRPr lang="en-IN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06E18-C386-4AF2-ACEC-D4ABCF2B18FE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33269158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CC400-6E8B-488F-B0D8-EF4C01DDC8E2}" type="datetimeFigureOut">
              <a:rPr lang="en-IN" smtClean="0"/>
              <a:t>22-12-2019</a:t>
            </a:fld>
            <a:endParaRPr lang="en-IN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06E18-C386-4AF2-ACEC-D4ABCF2B18FE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17319802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CC400-6E8B-488F-B0D8-EF4C01DDC8E2}" type="datetimeFigureOut">
              <a:rPr lang="en-IN" smtClean="0"/>
              <a:t>22-12-2019</a:t>
            </a:fld>
            <a:endParaRPr lang="en-IN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06E18-C386-4AF2-ACEC-D4ABCF2B18FE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6938837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CC400-6E8B-488F-B0D8-EF4C01DDC8E2}" type="datetimeFigureOut">
              <a:rPr lang="en-IN" smtClean="0"/>
              <a:t>22-12-2019</a:t>
            </a:fld>
            <a:endParaRPr lang="en-IN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06E18-C386-4AF2-ACEC-D4ABCF2B18FE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5528418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CC400-6E8B-488F-B0D8-EF4C01DDC8E2}" type="datetimeFigureOut">
              <a:rPr lang="en-IN" smtClean="0"/>
              <a:t>22-12-2019</a:t>
            </a:fld>
            <a:endParaRPr lang="en-IN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06E18-C386-4AF2-ACEC-D4ABCF2B18FE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11463063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CC400-6E8B-488F-B0D8-EF4C01DDC8E2}" type="datetimeFigureOut">
              <a:rPr lang="en-IN" smtClean="0"/>
              <a:t>22-12-2019</a:t>
            </a:fld>
            <a:endParaRPr lang="en-IN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06E18-C386-4AF2-ACEC-D4ABCF2B18FE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8294969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CC400-6E8B-488F-B0D8-EF4C01DDC8E2}" type="datetimeFigureOut">
              <a:rPr lang="en-IN" smtClean="0"/>
              <a:t>22-12-2019</a:t>
            </a:fld>
            <a:endParaRPr lang="en-IN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06E18-C386-4AF2-ACEC-D4ABCF2B18FE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3027940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2CC400-6E8B-488F-B0D8-EF4C01DDC8E2}" type="datetimeFigureOut">
              <a:rPr lang="en-IN" smtClean="0"/>
              <a:t>22-12-2019</a:t>
            </a:fld>
            <a:endParaRPr lang="en-IN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706E18-C386-4AF2-ACEC-D4ABCF2B18FE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2180178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6191"/>
          <a:stretch/>
        </p:blipFill>
        <p:spPr>
          <a:xfrm>
            <a:off x="5881749" y="2270904"/>
            <a:ext cx="441083" cy="958393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94" r="44579"/>
          <a:stretch/>
        </p:blipFill>
        <p:spPr>
          <a:xfrm>
            <a:off x="4900737" y="2276526"/>
            <a:ext cx="439947" cy="949753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r="47916" b="458"/>
          <a:stretch/>
        </p:blipFill>
        <p:spPr>
          <a:xfrm>
            <a:off x="6892520" y="2273924"/>
            <a:ext cx="439682" cy="952355"/>
          </a:xfrm>
          <a:prstGeom prst="rect">
            <a:avLst/>
          </a:prstGeom>
        </p:spPr>
      </p:pic>
      <p:sp>
        <p:nvSpPr>
          <p:cNvPr id="30" name="TextBox 29"/>
          <p:cNvSpPr txBox="1"/>
          <p:nvPr/>
        </p:nvSpPr>
        <p:spPr>
          <a:xfrm>
            <a:off x="4162248" y="3688239"/>
            <a:ext cx="432016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. S1. MOPS gel shows the qualities of stimulant ribosomal rRNAs.</a:t>
            </a:r>
            <a:endParaRPr lang="en-IN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efore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icroinjection, 100 ng of column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urified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RNAs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rom </a:t>
            </a:r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oli,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zebrafish and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hicken were run in 1.5% MOPS denaturing agarose gel to assess their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qualities.</a:t>
            </a:r>
            <a:endParaRPr lang="en-I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 rot="19548997">
            <a:off x="5884832" y="1787586"/>
            <a:ext cx="1156975" cy="254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Zebrafish</a:t>
            </a:r>
            <a:r>
              <a:rPr lang="en-IN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r</a:t>
            </a:r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NA</a:t>
            </a:r>
            <a:endParaRPr lang="en-I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 rot="19548997">
            <a:off x="4891894" y="1849379"/>
            <a:ext cx="93110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00" i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IN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. coli r</a:t>
            </a:r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NA</a:t>
            </a:r>
            <a:endParaRPr lang="en-I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5789036" y="2257714"/>
            <a:ext cx="6064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0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8S</a:t>
            </a:r>
            <a:endParaRPr lang="en-IN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828332" y="2274360"/>
            <a:ext cx="6064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0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3S</a:t>
            </a:r>
            <a:endParaRPr lang="en-IN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790562" y="2710726"/>
            <a:ext cx="6064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IN" sz="10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S</a:t>
            </a:r>
            <a:endParaRPr lang="en-IN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820390" y="2722660"/>
            <a:ext cx="6064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0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6S</a:t>
            </a:r>
            <a:endParaRPr lang="en-IN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 rot="19548997">
            <a:off x="6925150" y="1836659"/>
            <a:ext cx="10402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hicken</a:t>
            </a:r>
            <a:r>
              <a:rPr lang="en-IN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r</a:t>
            </a:r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NA</a:t>
            </a:r>
            <a:endParaRPr lang="en-I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6811434" y="2259188"/>
            <a:ext cx="6064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0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8S</a:t>
            </a:r>
            <a:endParaRPr lang="en-IN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6804082" y="2667818"/>
            <a:ext cx="6064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IN" sz="10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S</a:t>
            </a:r>
            <a:endParaRPr lang="en-IN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7250858" y="2372047"/>
            <a:ext cx="5500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.4 kb</a:t>
            </a:r>
            <a:endParaRPr lang="en-I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7239821" y="2846037"/>
            <a:ext cx="5500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.8 kb</a:t>
            </a:r>
            <a:endParaRPr lang="en-I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5273624" y="2436427"/>
            <a:ext cx="5500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.9 kb</a:t>
            </a:r>
            <a:endParaRPr lang="en-I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5251410" y="2882579"/>
            <a:ext cx="5500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.5 kb</a:t>
            </a:r>
            <a:endParaRPr lang="en-I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6247189" y="2397549"/>
            <a:ext cx="5500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.1 kb</a:t>
            </a:r>
            <a:endParaRPr lang="en-I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6231014" y="2872784"/>
            <a:ext cx="6407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.88 kb</a:t>
            </a:r>
            <a:endParaRPr lang="en-I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184201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668</TotalTime>
  <Words>71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nal results</dc:title>
  <dc:creator>Abhishikta Basu</dc:creator>
  <cp:lastModifiedBy>Abhishikta Basu</cp:lastModifiedBy>
  <cp:revision>1022</cp:revision>
  <cp:lastPrinted>2019-02-25T07:19:18Z</cp:lastPrinted>
  <dcterms:created xsi:type="dcterms:W3CDTF">2018-11-09T05:24:25Z</dcterms:created>
  <dcterms:modified xsi:type="dcterms:W3CDTF">2019-12-21T15:35:32Z</dcterms:modified>
</cp:coreProperties>
</file>